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2478" y="1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53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5233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36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923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0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3526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8973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2642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2049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006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789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9242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3836" y="5310472"/>
            <a:ext cx="4806000" cy="351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 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6926" y="1551349"/>
            <a:ext cx="4806000" cy="351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1524893" y="4032720"/>
            <a:ext cx="288032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" name="Connecteur droit avec flèche 4"/>
          <p:cNvCxnSpPr/>
          <p:nvPr/>
        </p:nvCxnSpPr>
        <p:spPr>
          <a:xfrm>
            <a:off x="1668909" y="4248744"/>
            <a:ext cx="0" cy="187220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-8763" y="35496"/>
            <a:ext cx="6822139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</a:t>
            </a:r>
            <a:r>
              <a:rPr lang="en-US" sz="1100" b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igure </a:t>
            </a:r>
            <a:r>
              <a:rPr lang="en-US" sz="11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4</a:t>
            </a:r>
            <a:r>
              <a:rPr lang="en-US" sz="1100" b="1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: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(for the mean of all other variables of the model) hazard ratio of event (relapse or death) for each value of CD3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. After adjustment for confounding factors (albumin and allogeneic stem-cell transplantation), event rate significantly (P=0.0006) increased from CD3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&gt; 0.10% in patients treated with Intensive Chemotherapy. Dashed lines correspond to 95% confidence interval of hazard ratio. First graph was limited to subjects with CD3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lower than 80% because the small number of subjects with CD3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≥ 80% (N=6) conducted to an unstable evaluation of the CD34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8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23</a:t>
            </a:r>
            <a:r>
              <a:rPr 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 effect beyond 80%.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9657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3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ete</dc:creator>
  <cp:lastModifiedBy>François Vergez</cp:lastModifiedBy>
  <cp:revision>7</cp:revision>
  <cp:lastPrinted>2019-05-27T14:35:17Z</cp:lastPrinted>
  <dcterms:created xsi:type="dcterms:W3CDTF">2019-05-27T14:26:13Z</dcterms:created>
  <dcterms:modified xsi:type="dcterms:W3CDTF">2019-09-26T16:28:53Z</dcterms:modified>
</cp:coreProperties>
</file>